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10" autoAdjust="0"/>
    <p:restoredTop sz="88813" autoAdjust="0"/>
  </p:normalViewPr>
  <p:slideViewPr>
    <p:cSldViewPr snapToGrid="0" showGuides="1">
      <p:cViewPr varScale="1">
        <p:scale>
          <a:sx n="151" d="100"/>
          <a:sy n="151" d="100"/>
        </p:scale>
        <p:origin x="150" y="31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Real-time PCR-positive without mutation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bg1"/>
                    </a:solidFill>
                    <a:latin typeface="Century" panose="02040604050505020304" pitchFamily="18" charset="0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15</c:f>
              <c:strCache>
                <c:ptCount val="14"/>
                <c:pt idx="0">
                  <c:v>Nov.</c:v>
                </c:pt>
                <c:pt idx="1">
                  <c:v>Dec.</c:v>
                </c:pt>
                <c:pt idx="2">
                  <c:v>Jan.</c:v>
                </c:pt>
                <c:pt idx="3">
                  <c:v>Feb.</c:v>
                </c:pt>
                <c:pt idx="4">
                  <c:v>Mar.</c:v>
                </c:pt>
                <c:pt idx="5">
                  <c:v>Apr.</c:v>
                </c:pt>
                <c:pt idx="6">
                  <c:v>May</c:v>
                </c:pt>
                <c:pt idx="7">
                  <c:v>June</c:v>
                </c:pt>
                <c:pt idx="8">
                  <c:v>July</c:v>
                </c:pt>
                <c:pt idx="9">
                  <c:v>Aug.</c:v>
                </c:pt>
                <c:pt idx="10">
                  <c:v>Sep.</c:v>
                </c:pt>
                <c:pt idx="11">
                  <c:v>Oct.</c:v>
                </c:pt>
                <c:pt idx="12">
                  <c:v>Nov.</c:v>
                </c:pt>
                <c:pt idx="13">
                  <c:v>Dec.</c:v>
                </c:pt>
              </c:strCache>
            </c:strRef>
          </c:cat>
          <c:val>
            <c:numRef>
              <c:f>Sheet1!$B$2:$B$15</c:f>
              <c:numCache>
                <c:formatCode>General</c:formatCode>
                <c:ptCount val="14"/>
                <c:pt idx="0">
                  <c:v>3</c:v>
                </c:pt>
                <c:pt idx="1">
                  <c:v>10</c:v>
                </c:pt>
                <c:pt idx="2">
                  <c:v>3</c:v>
                </c:pt>
                <c:pt idx="3">
                  <c:v>3</c:v>
                </c:pt>
                <c:pt idx="4">
                  <c:v>2</c:v>
                </c:pt>
                <c:pt idx="5">
                  <c:v>2</c:v>
                </c:pt>
                <c:pt idx="6">
                  <c:v>2</c:v>
                </c:pt>
                <c:pt idx="7">
                  <c:v>2</c:v>
                </c:pt>
                <c:pt idx="8">
                  <c:v>2</c:v>
                </c:pt>
                <c:pt idx="9">
                  <c:v>6</c:v>
                </c:pt>
                <c:pt idx="10">
                  <c:v>9</c:v>
                </c:pt>
                <c:pt idx="11">
                  <c:v>10</c:v>
                </c:pt>
                <c:pt idx="12">
                  <c:v>12</c:v>
                </c:pt>
                <c:pt idx="13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E84-47A2-AB42-5E66CD168D16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Real-time PCR-positive with mutation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dLbl>
              <c:idx val="1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38B9-4D59-B53D-2C5922EEDEB1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/>
                    </a:solidFill>
                    <a:latin typeface="Century" panose="02040604050505020304" pitchFamily="18" charset="0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15</c:f>
              <c:strCache>
                <c:ptCount val="14"/>
                <c:pt idx="0">
                  <c:v>Nov.</c:v>
                </c:pt>
                <c:pt idx="1">
                  <c:v>Dec.</c:v>
                </c:pt>
                <c:pt idx="2">
                  <c:v>Jan.</c:v>
                </c:pt>
                <c:pt idx="3">
                  <c:v>Feb.</c:v>
                </c:pt>
                <c:pt idx="4">
                  <c:v>Mar.</c:v>
                </c:pt>
                <c:pt idx="5">
                  <c:v>Apr.</c:v>
                </c:pt>
                <c:pt idx="6">
                  <c:v>May</c:v>
                </c:pt>
                <c:pt idx="7">
                  <c:v>June</c:v>
                </c:pt>
                <c:pt idx="8">
                  <c:v>July</c:v>
                </c:pt>
                <c:pt idx="9">
                  <c:v>Aug.</c:v>
                </c:pt>
                <c:pt idx="10">
                  <c:v>Sep.</c:v>
                </c:pt>
                <c:pt idx="11">
                  <c:v>Oct.</c:v>
                </c:pt>
                <c:pt idx="12">
                  <c:v>Nov.</c:v>
                </c:pt>
                <c:pt idx="13">
                  <c:v>Dec.</c:v>
                </c:pt>
              </c:strCache>
            </c:strRef>
          </c:cat>
          <c:val>
            <c:numRef>
              <c:f>Sheet1!$C$2:$C$15</c:f>
              <c:numCache>
                <c:formatCode>General</c:formatCode>
                <c:ptCount val="14"/>
                <c:pt idx="2">
                  <c:v>1</c:v>
                </c:pt>
                <c:pt idx="10">
                  <c:v>3</c:v>
                </c:pt>
                <c:pt idx="11">
                  <c:v>2</c:v>
                </c:pt>
                <c:pt idx="1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E84-47A2-AB42-5E66CD168D16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Real-time PCR-negative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/>
                    </a:solidFill>
                    <a:latin typeface="Century" panose="02040604050505020304" pitchFamily="18" charset="0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15</c:f>
              <c:strCache>
                <c:ptCount val="14"/>
                <c:pt idx="0">
                  <c:v>Nov.</c:v>
                </c:pt>
                <c:pt idx="1">
                  <c:v>Dec.</c:v>
                </c:pt>
                <c:pt idx="2">
                  <c:v>Jan.</c:v>
                </c:pt>
                <c:pt idx="3">
                  <c:v>Feb.</c:v>
                </c:pt>
                <c:pt idx="4">
                  <c:v>Mar.</c:v>
                </c:pt>
                <c:pt idx="5">
                  <c:v>Apr.</c:v>
                </c:pt>
                <c:pt idx="6">
                  <c:v>May</c:v>
                </c:pt>
                <c:pt idx="7">
                  <c:v>June</c:v>
                </c:pt>
                <c:pt idx="8">
                  <c:v>July</c:v>
                </c:pt>
                <c:pt idx="9">
                  <c:v>Aug.</c:v>
                </c:pt>
                <c:pt idx="10">
                  <c:v>Sep.</c:v>
                </c:pt>
                <c:pt idx="11">
                  <c:v>Oct.</c:v>
                </c:pt>
                <c:pt idx="12">
                  <c:v>Nov.</c:v>
                </c:pt>
                <c:pt idx="13">
                  <c:v>Dec.</c:v>
                </c:pt>
              </c:strCache>
            </c:strRef>
          </c:cat>
          <c:val>
            <c:numRef>
              <c:f>Sheet1!$D$2:$D$15</c:f>
              <c:numCache>
                <c:formatCode>General</c:formatCode>
                <c:ptCount val="14"/>
                <c:pt idx="0">
                  <c:v>4</c:v>
                </c:pt>
                <c:pt idx="1">
                  <c:v>9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5</c:v>
                </c:pt>
                <c:pt idx="6">
                  <c:v>2</c:v>
                </c:pt>
                <c:pt idx="7">
                  <c:v>3</c:v>
                </c:pt>
                <c:pt idx="8">
                  <c:v>5</c:v>
                </c:pt>
                <c:pt idx="9">
                  <c:v>6</c:v>
                </c:pt>
                <c:pt idx="10">
                  <c:v>3</c:v>
                </c:pt>
                <c:pt idx="11">
                  <c:v>9</c:v>
                </c:pt>
                <c:pt idx="12">
                  <c:v>11</c:v>
                </c:pt>
                <c:pt idx="13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E84-47A2-AB42-5E66CD168D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391561824"/>
        <c:axId val="1712472880"/>
      </c:barChart>
      <c:catAx>
        <c:axId val="13915618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1712472880"/>
        <c:crosses val="autoZero"/>
        <c:auto val="1"/>
        <c:lblAlgn val="ctr"/>
        <c:lblOffset val="100"/>
        <c:noMultiLvlLbl val="0"/>
      </c:catAx>
      <c:valAx>
        <c:axId val="17124728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13915618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064019171516604"/>
          <c:y val="7.5271184199378088E-2"/>
          <c:w val="0.55176930782202949"/>
          <c:h val="0.25462581854133143"/>
        </c:manualLayout>
      </c:layout>
      <c:overlay val="1"/>
      <c:spPr>
        <a:solidFill>
          <a:schemeClr val="bg1"/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Century" panose="02040604050505020304" pitchFamily="18" charset="0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DB0027-5483-4264-8020-45052CBE92D3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B1F9D4-68F9-41DE-9140-A4971A078F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92968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Age groups and detection of M. pneumoniae DNA by real-time PCR.  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4B1F9D4-68F9-41DE-9140-A4971A078FCA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17395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57A1-1921-41D8-A514-93A822FDE6A8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4A71-61DC-4923-8CCE-6076A63A8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27818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57A1-1921-41D8-A514-93A822FDE6A8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4A71-61DC-4923-8CCE-6076A63A8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19522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57A1-1921-41D8-A514-93A822FDE6A8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4A71-61DC-4923-8CCE-6076A63A8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5232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57A1-1921-41D8-A514-93A822FDE6A8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4A71-61DC-4923-8CCE-6076A63A8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64500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57A1-1921-41D8-A514-93A822FDE6A8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4A71-61DC-4923-8CCE-6076A63A8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13231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57A1-1921-41D8-A514-93A822FDE6A8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4A71-61DC-4923-8CCE-6076A63A8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02290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57A1-1921-41D8-A514-93A822FDE6A8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4A71-61DC-4923-8CCE-6076A63A8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60779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57A1-1921-41D8-A514-93A822FDE6A8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4A71-61DC-4923-8CCE-6076A63A8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29313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57A1-1921-41D8-A514-93A822FDE6A8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4A71-61DC-4923-8CCE-6076A63A8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51862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57A1-1921-41D8-A514-93A822FDE6A8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4A71-61DC-4923-8CCE-6076A63A8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8025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57A1-1921-41D8-A514-93A822FDE6A8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4A71-61DC-4923-8CCE-6076A63A8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08075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3C57A1-1921-41D8-A514-93A822FDE6A8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B64A71-61DC-4923-8CCE-6076A63A8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44314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コンテンツ プレースホルダー 7">
            <a:extLst>
              <a:ext uri="{FF2B5EF4-FFF2-40B4-BE49-F238E27FC236}">
                <a16:creationId xmlns:a16="http://schemas.microsoft.com/office/drawing/2014/main" id="{E30BD78A-E2D6-4630-885C-B69D68A1EC4D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894215688"/>
              </p:ext>
            </p:extLst>
          </p:nvPr>
        </p:nvGraphicFramePr>
        <p:xfrm>
          <a:off x="628650" y="1125415"/>
          <a:ext cx="7886700" cy="50515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111A8DE-507A-4B47-A5FD-DA7AE3B9001C}"/>
              </a:ext>
            </a:extLst>
          </p:cNvPr>
          <p:cNvSpPr txBox="1"/>
          <p:nvPr/>
        </p:nvSpPr>
        <p:spPr>
          <a:xfrm>
            <a:off x="1202787" y="6140547"/>
            <a:ext cx="5822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Century" panose="02040604050505020304" pitchFamily="18" charset="0"/>
              </a:rPr>
              <a:t>2018</a:t>
            </a:r>
            <a:endParaRPr kumimoji="1" lang="ja-JP" altLang="en-US" sz="1400" dirty="0">
              <a:latin typeface="Century" panose="020406040505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4F791BC-7F8A-4F06-BFC1-C1007604B681}"/>
              </a:ext>
            </a:extLst>
          </p:cNvPr>
          <p:cNvSpPr txBox="1"/>
          <p:nvPr/>
        </p:nvSpPr>
        <p:spPr>
          <a:xfrm>
            <a:off x="4949478" y="6140547"/>
            <a:ext cx="5822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Century" panose="02040604050505020304" pitchFamily="18" charset="0"/>
              </a:rPr>
              <a:t>2019</a:t>
            </a:r>
            <a:endParaRPr kumimoji="1" lang="ja-JP" altLang="en-US" sz="1400" dirty="0">
              <a:latin typeface="Century" panose="02040604050505020304" pitchFamily="18" charset="0"/>
            </a:endParaRPr>
          </a:p>
        </p:txBody>
      </p: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D17009FA-2527-4DFC-BE62-117012DC7B47}"/>
              </a:ext>
            </a:extLst>
          </p:cNvPr>
          <p:cNvCxnSpPr/>
          <p:nvPr/>
        </p:nvCxnSpPr>
        <p:spPr>
          <a:xfrm>
            <a:off x="2067950" y="5936563"/>
            <a:ext cx="0" cy="54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77547A6-FAF9-44BF-825B-0940D53846EC}"/>
              </a:ext>
            </a:extLst>
          </p:cNvPr>
          <p:cNvSpPr txBox="1"/>
          <p:nvPr/>
        </p:nvSpPr>
        <p:spPr>
          <a:xfrm rot="16200000">
            <a:off x="-196940" y="3404364"/>
            <a:ext cx="11544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Century" panose="02040604050505020304" pitchFamily="18" charset="0"/>
              </a:rPr>
              <a:t>No. of cases</a:t>
            </a:r>
            <a:endParaRPr kumimoji="1" lang="ja-JP" altLang="en-US" sz="1400" dirty="0">
              <a:latin typeface="Century" panose="020406040505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09618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32</TotalTime>
  <Words>20</Words>
  <Application>Microsoft Office PowerPoint</Application>
  <PresentationFormat>画面に合わせる (4:3)</PresentationFormat>
  <Paragraphs>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Century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石黒　信久</dc:creator>
  <cp:lastModifiedBy>石黒　信久</cp:lastModifiedBy>
  <cp:revision>27</cp:revision>
  <dcterms:created xsi:type="dcterms:W3CDTF">2021-01-23T10:40:31Z</dcterms:created>
  <dcterms:modified xsi:type="dcterms:W3CDTF">2021-08-24T07:39:41Z</dcterms:modified>
</cp:coreProperties>
</file>